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7BB190-AB73-4845-B96B-BE38AAA24C84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4CD787-04C3-4810-A2A1-42CDC909A7A7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527E3-F03D-4A31-B9A4-EFF1304ADC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FC39E-2A3F-4F6F-8794-EB53753062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CD9C6B-7B02-47AC-BE2A-679411A433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9AFE5-4680-42F5-8F6C-7D2CB1296D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3E3DC-F871-42E8-9D38-0FC490F35D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1AA20-A980-4878-8B20-AC8CA0AD26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5BBBB-77A2-47C1-947A-5CF86309E3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728EB-209B-488B-9A28-16E8142E1F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D760D-8BFA-4C9C-946E-301CDA4364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9B34B4-246B-4196-BFD1-8D9C0F683F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A81AA-3724-428D-9A13-4D266F4D54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C856C-1C7E-43E4-9A83-CA5C4753F9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433B8B-0BC6-449B-BB20-5257765D0DD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"/>
          <p:cNvSpPr/>
          <p:nvPr/>
        </p:nvSpPr>
        <p:spPr>
          <a:xfrm>
            <a:off x="971640" y="3429000"/>
            <a:ext cx="3600360" cy="158436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Calibri"/>
                <a:ea typeface="Times New Roman"/>
              </a:rPr>
              <a:t>Model 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Grade repetition (ref: No)----------------------------------------- OR = 1.60 [1.31 – 1.95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Not living at parent’s home (ref: No)--------------------------- OR = 1.40 [1.09 – 1.81]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b0f0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b0f0"/>
                </a:solidFill>
                <a:latin typeface="Calibri"/>
                <a:ea typeface="Times New Roman"/>
              </a:rPr>
              <a:t>Negative relationship with the mother (ref: No)------------ OR = 2.59 [1.79 – 3.75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5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b050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b050"/>
                </a:solidFill>
                <a:latin typeface="Calibri"/>
                <a:ea typeface="Times New Roman"/>
              </a:rPr>
              <a:t>Negative relationship with the father (ref: No) ------------- OR = 2.35 [1.76 – 3.13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ff0066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 </a:t>
            </a:r>
            <a:r>
              <a:rPr b="1" i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Parents not living together with negative relationship (ref: Parents living together with negative relationship)---------------------------- </a:t>
            </a: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OR = 1.32 [1.01 – 1.71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ff0066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Parents living together with negative relationship  (ref: Parents living together with positive relationship) ----------------------------------------- OR = 2.56 [1.73 – 2.95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984807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 </a:t>
            </a:r>
            <a:r>
              <a:rPr b="1" i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Alcohol use (ref: No)-</a:t>
            </a: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----------------------------------------------- OR = 1.32 [1.02 – 1.69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984807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Tobacco use (ref: No) ---------------------------------------------- OR = 2.09 [1.59 – 2.75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984807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Marijuana use (ref: No) ------------------------------------------- OR = 1.37 [1.08 – 1.73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"/>
          <p:cNvSpPr/>
          <p:nvPr/>
        </p:nvSpPr>
        <p:spPr>
          <a:xfrm>
            <a:off x="4643280" y="1268280"/>
            <a:ext cx="2160720" cy="18734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Gir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Comparis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</a:rPr>
              <a:t>Grade (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[N = 11262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</a:rPr>
              <a:t>/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</a:rPr>
              <a:t>(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Depression = N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Suicidal attempt = Ye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[N = 1239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4"/>
          <p:cNvSpPr/>
          <p:nvPr/>
        </p:nvSpPr>
        <p:spPr>
          <a:xfrm>
            <a:off x="4643280" y="3429000"/>
            <a:ext cx="2160720" cy="158436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Bo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Comparis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</a:rPr>
              <a:t>Grade (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[N = 12744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</a:rPr>
              <a:t>/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Calibri"/>
              </a:rPr>
              <a:t>(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Depression = N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Suicidal attempt = Ye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[N = 453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5"/>
          <p:cNvSpPr/>
          <p:nvPr/>
        </p:nvSpPr>
        <p:spPr>
          <a:xfrm>
            <a:off x="971640" y="1268280"/>
            <a:ext cx="3600360" cy="18734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Calibri"/>
                <a:ea typeface="Times New Roman"/>
              </a:rPr>
              <a:t>Model 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Education (ref: not out of school) ------------------------------- </a:t>
            </a: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OR = 1.72 [1.13 – 2.62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Grade repetition (ref: No)----------------------------------------- OR = 1.95 [1.72 – 2.21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Not living at parent’s home (ref: No)--------------------------- OR = 1.66 [1.41 – 1.97]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b0f0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b0f0"/>
                </a:solidFill>
                <a:latin typeface="Calibri"/>
                <a:ea typeface="Times New Roman"/>
              </a:rPr>
              <a:t>Negative relationship with the mother (ref: No)------------ OR = 2.36 [1.83 – 3.06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5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b050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b050"/>
                </a:solidFill>
                <a:latin typeface="Calibri"/>
                <a:ea typeface="Times New Roman"/>
              </a:rPr>
              <a:t>Negative relationship with the father (ref: No) ------------- OR = 2.16 [1.80 – 2.59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ff0066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Parents not living together with positive relationship (ref: Parents living together with negative relationship) ---------------------------- OR = 1.32 [1.04 – 1.68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ff0066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Parents not living together with negative relationship (ref: Parents living together with negative relationship) ---------------------------- OR = 1.47 [1.25 – 1.74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ff0066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ff0066"/>
                </a:solidFill>
                <a:latin typeface="Calibri"/>
                <a:ea typeface="Times New Roman"/>
              </a:rPr>
              <a:t>Parents living together with negative relationship  (ref: Parents living together with positive relationship) ----------------------------------------- OR = 1.61 [1.35 – 1.93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984807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 </a:t>
            </a:r>
            <a:r>
              <a:rPr b="1" i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Alcohol use (ref: No)-</a:t>
            </a: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----------------------------------------------- OR = 1.99 [1.55 – 2.55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984807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Tobacco use (ref: No) ---------------------------------------------- OR = 2.32 [1.89 – 2.86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984807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984807"/>
                </a:solidFill>
                <a:latin typeface="Calibri"/>
                <a:ea typeface="Times New Roman"/>
              </a:rPr>
              <a:t>Marijuana use (ref: No) ------------------------------------------- OR = 1.82 [1.51 – 2.20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5T10:13:27Z</dcterms:created>
  <dc:creator>Angèle Consoli</dc:creator>
  <dc:description/>
  <dc:language>en-US</dc:language>
  <cp:lastModifiedBy>3020938</cp:lastModifiedBy>
  <dcterms:modified xsi:type="dcterms:W3CDTF">2013-02-18T17:02:08Z</dcterms:modified>
  <cp:revision>5</cp:revision>
  <dc:subject/>
  <dc:title>Diapositive 1</dc:title>
</cp:coreProperties>
</file>